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-114" y="-2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0DC85D-DCBD-43AC-8FD0-10F65CD1FAEE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7BF4BE-E66A-4B10-9104-3AD9AA860D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172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1: Consort Diagram</a:t>
            </a:r>
            <a:br>
              <a:rPr lang="en-US" dirty="0"/>
            </a:br>
            <a:r>
              <a:rPr lang="en-US" dirty="0"/>
              <a:t>Trial consort diagram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B7638C6-9100-4EF2-B2A1-74047FCDE54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04563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E9D0E9E-AE84-0003-1718-5A62F2F258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761ED867-0E40-F5EF-EA49-A181CAAED1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413F9EF-9B35-9997-D7A5-82219083D7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C096982-0121-EBC7-E530-5110B19F8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CBE029F-390F-7333-F3CA-42D37EEB9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7878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6C1AEF-D0BD-EF0C-DD88-088B0ECBAD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E5CD616-621D-CAA8-B50D-F0BE68014A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EA3959D-2603-3CDF-D821-BC3E520618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312DA39-D2BB-B412-EEFE-73C2BF04F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8634C85-01F7-B418-AC8A-3AAF539987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293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D30B2AD-A5C7-48D9-E550-B839CF3D3C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A929867-10DA-86F2-11EC-F1E8B8015C8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81C3A01-E637-A5D8-8025-EEA718CB99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388A79-73C5-9171-0465-14539BFC13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9E9BD69-2CE0-2C98-B4D8-798178027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8683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A969B13-15B7-BF7B-CEA5-58B9347B3E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3DA01F2-D2EE-1F7A-0326-B0FE6D1785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7ABB2D6-ADEA-D30A-5929-BAE6232F7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120FE54-7256-B6D8-B4C7-C05469197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FA6C8B4-F4C3-08BF-0CF4-1216F981BC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7031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C0E232-0067-7571-6A99-4F30ECDA2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2453B8C8-4842-7F6E-57B2-6527580BF0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7E79711-B30A-3523-8769-378B34CDD4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BEE5E58-9516-6DA2-907F-0076ECEB80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EEA0693-326C-D537-18AD-CEDD523F1F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5569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2C98D5E-BA31-076B-F852-D4DCC913C4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A02F7A0-8660-2EDE-8757-12D9E3A59D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4C7680F-DBAA-5B24-0BF8-BC4B9BA664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F75991F-1BD8-553A-AF96-88F855E03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17ACA31-3AD4-0C59-595C-DC67ECC0F9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BA317747-96BF-7CB1-7C84-B40AF2EC9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729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F858DD6-57CE-90CB-979B-B953AB6ACB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AABC7AF-FBFA-DA56-4454-415E6F953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EC4BBE87-A61A-6CAC-9A9B-02A0CD99C2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7F96FA03-AB9B-6B2B-1C60-AE2C2B9D34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C3116C7F-3E40-72F1-76B0-C46F7E31E4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08E60FD9-F5C3-593D-78B9-D63F16EDC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08061F08-DEFD-E291-BD2C-4B84CB1014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BD7B4882-080F-CC36-9054-193E353C1B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310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D49D839-92F4-65A3-9E60-9E3EA0D6AC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33AEB0C-E159-293D-1599-4B62525A39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90714181-C056-2AEE-48A9-41E0F617C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CB614FC-F57A-A1AF-52FC-8CE105CC2A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586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0AC0A7FC-BEF6-96BF-6662-F08C900044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14095BC-6286-A61B-0E5E-A86B624B2C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273C15C0-72A8-BC17-EAC7-C85C38139E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937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150BFD0-1FDE-136A-BF2C-65B01C75F8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A1CFAC6-BEE2-72C6-16BD-02710BF809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53B6C91-4832-AB2C-8876-E160CCE0C4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8A732B0-07BB-E1B9-1625-55306EFF7B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08BCC94F-DC34-9E94-A321-16DBFC8F6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05FFFD24-914B-3B7A-C373-B55F97DE74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9594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4E7F53D-3D8A-9DCF-F1D3-7D0F038C3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54C5A1C9-B7C2-4F01-D8E0-F6DBF98BD3D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B3B4DB1B-6DA0-961A-0C3F-D4CD44D194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E6F6DE6-4405-1CF5-D2C9-122151DE2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65CD8E3-FF92-6E2E-79CF-9092A9C34B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194A1CE-1753-CB83-3E10-9E9B58EDEC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219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E0F673E0-567F-BA92-139D-657B3B9234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BC8F0A1-DE84-CBED-0ED6-7E05FADDD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578EC1B-E426-E17C-90B3-8289E735D1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A5B4E-6F03-438E-ACFC-0A8A91D80946}" type="datetimeFigureOut">
              <a:rPr lang="en-US" smtClean="0"/>
              <a:t>4/1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9FD1095-B5AA-11B5-AFEB-D6E2E6C2C24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A8B061E-07F4-DC36-F83F-CC3B24B509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ACE41-6A44-4651-BEAE-07BAB9BF8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52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1981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0000" lnSpcReduction="20000"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Supplementary Figure 1</a:t>
            </a:r>
            <a:br>
              <a:rPr lang="en-US" dirty="0"/>
            </a:br>
            <a:r>
              <a:rPr lang="en-US" dirty="0"/>
              <a:t>Consort Diagram</a:t>
            </a:r>
          </a:p>
        </p:txBody>
      </p:sp>
      <p:sp>
        <p:nvSpPr>
          <p:cNvPr id="6" name="Rectangle 5"/>
          <p:cNvSpPr/>
          <p:nvPr/>
        </p:nvSpPr>
        <p:spPr>
          <a:xfrm>
            <a:off x="4800600" y="1414790"/>
            <a:ext cx="2515306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143500" y="1381780"/>
            <a:ext cx="1752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Enrolled in Trial (n=16)</a:t>
            </a:r>
          </a:p>
        </p:txBody>
      </p:sp>
      <p:cxnSp>
        <p:nvCxnSpPr>
          <p:cNvPr id="8" name="Straight Arrow Connector 7"/>
          <p:cNvCxnSpPr>
            <a:stCxn id="7" idx="2"/>
          </p:cNvCxnSpPr>
          <p:nvPr/>
        </p:nvCxnSpPr>
        <p:spPr>
          <a:xfrm>
            <a:off x="6019800" y="1905000"/>
            <a:ext cx="0" cy="762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4800600" y="2690687"/>
            <a:ext cx="2590800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143500" y="2657677"/>
            <a:ext cx="19431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Received intervention </a:t>
            </a:r>
          </a:p>
          <a:p>
            <a:pPr algn="ctr"/>
            <a:r>
              <a:rPr lang="en-US" sz="1400" dirty="0"/>
              <a:t>(n=16)</a:t>
            </a:r>
          </a:p>
        </p:txBody>
      </p:sp>
      <p:sp>
        <p:nvSpPr>
          <p:cNvPr id="11" name="AutoShape 2"/>
          <p:cNvSpPr>
            <a:spLocks noChangeArrowheads="1"/>
          </p:cNvSpPr>
          <p:nvPr/>
        </p:nvSpPr>
        <p:spPr bwMode="auto">
          <a:xfrm>
            <a:off x="5302250" y="2139156"/>
            <a:ext cx="1435100" cy="293688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ts val="1000"/>
              </a:spcBef>
              <a:spcAft>
                <a:spcPct val="0"/>
              </a:spcAft>
            </a:pPr>
            <a:r>
              <a:rPr lang="en-US" altLang="en-US" sz="1300" b="1" dirty="0">
                <a:solidFill>
                  <a:srgbClr val="4F81BD"/>
                </a:solidFill>
                <a:latin typeface="Candara" pitchFamily="34" charset="0"/>
                <a:cs typeface="Arial" pitchFamily="34" charset="0"/>
              </a:rPr>
              <a:t>Intervention</a:t>
            </a:r>
            <a:endParaRPr lang="en-US" altLang="en-US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6019800" y="3200400"/>
            <a:ext cx="0" cy="762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143500" y="3953078"/>
            <a:ext cx="19431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Lost to Follow up (n=0)</a:t>
            </a:r>
          </a:p>
        </p:txBody>
      </p:sp>
      <p:sp>
        <p:nvSpPr>
          <p:cNvPr id="14" name="AutoShape 2"/>
          <p:cNvSpPr>
            <a:spLocks noChangeArrowheads="1"/>
          </p:cNvSpPr>
          <p:nvPr/>
        </p:nvSpPr>
        <p:spPr bwMode="auto">
          <a:xfrm>
            <a:off x="5302250" y="3434556"/>
            <a:ext cx="1435100" cy="293688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ts val="1000"/>
              </a:spcBef>
              <a:spcAft>
                <a:spcPct val="0"/>
              </a:spcAft>
            </a:pPr>
            <a:r>
              <a:rPr lang="en-US" altLang="en-US" sz="1300" b="1" dirty="0">
                <a:solidFill>
                  <a:srgbClr val="4F81BD"/>
                </a:solidFill>
                <a:latin typeface="Candara" pitchFamily="34" charset="0"/>
                <a:cs typeface="Arial" pitchFamily="34" charset="0"/>
              </a:rPr>
              <a:t>Follow up</a:t>
            </a:r>
            <a:endParaRPr lang="en-US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4800600" y="3986086"/>
            <a:ext cx="2515306" cy="738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105400" y="4163254"/>
            <a:ext cx="20955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Withdrew Consent (n=0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724400" y="4367242"/>
            <a:ext cx="2667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Discontinued Due To Toxicity(n=0)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>
            <a:off x="6096706" y="4800600"/>
            <a:ext cx="0" cy="7620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105400" y="5553278"/>
            <a:ext cx="194310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Analyzed (n=16)</a:t>
            </a:r>
          </a:p>
          <a:p>
            <a:pPr algn="ctr"/>
            <a:r>
              <a:rPr lang="en-US" sz="1400" dirty="0"/>
              <a:t>PFS Data (n=16)</a:t>
            </a:r>
          </a:p>
          <a:p>
            <a:pPr algn="ctr"/>
            <a:r>
              <a:rPr lang="en-US" sz="1400" dirty="0"/>
              <a:t>OS Data (n=16)</a:t>
            </a:r>
          </a:p>
          <a:p>
            <a:pPr algn="ctr"/>
            <a:endParaRPr lang="en-US" sz="1400" dirty="0"/>
          </a:p>
          <a:p>
            <a:pPr algn="ctr"/>
            <a:endParaRPr lang="en-US" sz="1400" dirty="0"/>
          </a:p>
        </p:txBody>
      </p:sp>
      <p:sp>
        <p:nvSpPr>
          <p:cNvPr id="20" name="AutoShape 2"/>
          <p:cNvSpPr>
            <a:spLocks noChangeArrowheads="1"/>
          </p:cNvSpPr>
          <p:nvPr/>
        </p:nvSpPr>
        <p:spPr bwMode="auto">
          <a:xfrm>
            <a:off x="5379156" y="5034756"/>
            <a:ext cx="1435100" cy="293688"/>
          </a:xfrm>
          <a:prstGeom prst="roundRect">
            <a:avLst>
              <a:gd name="adj" fmla="val 16667"/>
            </a:avLst>
          </a:prstGeom>
          <a:solidFill>
            <a:srgbClr val="A9C7FD"/>
          </a:solidFill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45720" tIns="45720" rIns="45720" bIns="45720" numCol="1" anchor="t" anchorCtr="0" compatLnSpc="1">
            <a:prstTxWarp prst="textNoShape">
              <a:avLst/>
            </a:prstTxWarp>
          </a:bodyPr>
          <a:lstStyle/>
          <a:p>
            <a:pPr algn="ctr" fontAlgn="base">
              <a:spcBef>
                <a:spcPts val="1000"/>
              </a:spcBef>
              <a:spcAft>
                <a:spcPct val="0"/>
              </a:spcAft>
            </a:pPr>
            <a:r>
              <a:rPr lang="en-US" altLang="en-US" sz="1300" b="1" dirty="0">
                <a:solidFill>
                  <a:srgbClr val="4F81BD"/>
                </a:solidFill>
                <a:latin typeface="Candara" pitchFamily="34" charset="0"/>
                <a:cs typeface="Arial" pitchFamily="34" charset="0"/>
              </a:rPr>
              <a:t>Analysis</a:t>
            </a:r>
            <a:endParaRPr lang="en-US" alt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4800600" y="5586286"/>
            <a:ext cx="2515306" cy="7383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ysClr val="windowText" lastClr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5208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Custom</PresentationFormat>
  <Paragraphs>1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.D. Anderson Cancer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n,John Paul</dc:creator>
  <cp:lastModifiedBy>njh219</cp:lastModifiedBy>
  <cp:revision>2</cp:revision>
  <dcterms:created xsi:type="dcterms:W3CDTF">2024-03-22T19:25:19Z</dcterms:created>
  <dcterms:modified xsi:type="dcterms:W3CDTF">2024-04-17T21:57:40Z</dcterms:modified>
</cp:coreProperties>
</file>